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84" r:id="rId2"/>
  </p:sldIdLst>
  <p:sldSz cx="6858000" cy="9906000" type="A4"/>
  <p:notesSz cx="9931400" cy="67945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510" userDrawn="1">
          <p15:clr>
            <a:srgbClr val="A4A3A4"/>
          </p15:clr>
        </p15:guide>
        <p15:guide id="2" pos="391" userDrawn="1">
          <p15:clr>
            <a:srgbClr val="A4A3A4"/>
          </p15:clr>
        </p15:guide>
        <p15:guide id="6" orient="horz" pos="6136" userDrawn="1">
          <p15:clr>
            <a:srgbClr val="A4A3A4"/>
          </p15:clr>
        </p15:guide>
        <p15:guide id="7" pos="3884" userDrawn="1">
          <p15:clr>
            <a:srgbClr val="A4A3A4"/>
          </p15:clr>
        </p15:guide>
        <p15:guide id="8" orient="horz" pos="4435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E09670F-CE05-9C7F-2A18-F12607C6DEEE}" name="Eva Herrero Serrano" initials="EHS" userId="S::eh642@cam.ac.uk::30ee73c8-4441-48c1-9b41-6efa0a64ae52" providerId="AD"/>
  <p188:author id="{14A239CE-EE99-779E-A9A8-70BD1B86BCFC}" name="Alex Webb" initials="AW" userId="S::aarw2@cam.ac.uk::6e034127-e0df-4368-bc35-fbdfd215004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D92"/>
    <a:srgbClr val="163E62"/>
    <a:srgbClr val="4C95D9"/>
    <a:srgbClr val="46B1E1"/>
    <a:srgbClr val="7A81FF"/>
    <a:srgbClr val="0432FF"/>
    <a:srgbClr val="163E63"/>
    <a:srgbClr val="FF8AD8"/>
    <a:srgbClr val="ECECEC"/>
    <a:srgbClr val="4D95D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47F92C8-9066-C1C2-C98C-9CCF82F59B3E}" v="38" dt="2025-07-01T13:45:27.52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80" d="100"/>
          <a:sy n="80" d="100"/>
        </p:scale>
        <p:origin x="3576" y="192"/>
      </p:cViewPr>
      <p:guideLst>
        <p:guide orient="horz" pos="1510"/>
        <p:guide pos="391"/>
        <p:guide orient="horz" pos="6136"/>
        <p:guide pos="3884"/>
        <p:guide orient="horz" pos="44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8/10/relationships/authors" Target="author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va Herrero Serrano" userId="30ee73c8-4441-48c1-9b41-6efa0a64ae52" providerId="ADAL" clId="{73C8A755-2F19-1F40-B457-F6EEA28A134F}"/>
    <pc:docChg chg="delSld">
      <pc:chgData name="Eva Herrero Serrano" userId="30ee73c8-4441-48c1-9b41-6efa0a64ae52" providerId="ADAL" clId="{73C8A755-2F19-1F40-B457-F6EEA28A134F}" dt="2025-07-02T13:32:19.997" v="6" actId="2696"/>
      <pc:docMkLst>
        <pc:docMk/>
      </pc:docMkLst>
      <pc:sldChg chg="del">
        <pc:chgData name="Eva Herrero Serrano" userId="30ee73c8-4441-48c1-9b41-6efa0a64ae52" providerId="ADAL" clId="{73C8A755-2F19-1F40-B457-F6EEA28A134F}" dt="2025-07-02T13:32:19.997" v="6" actId="2696"/>
        <pc:sldMkLst>
          <pc:docMk/>
          <pc:sldMk cId="2380616195" sldId="400"/>
        </pc:sldMkLst>
      </pc:sldChg>
      <pc:sldChg chg="del">
        <pc:chgData name="Eva Herrero Serrano" userId="30ee73c8-4441-48c1-9b41-6efa0a64ae52" providerId="ADAL" clId="{73C8A755-2F19-1F40-B457-F6EEA28A134F}" dt="2025-07-02T13:32:17.153" v="0" actId="2696"/>
        <pc:sldMkLst>
          <pc:docMk/>
          <pc:sldMk cId="548085851" sldId="404"/>
        </pc:sldMkLst>
      </pc:sldChg>
      <pc:sldChg chg="del">
        <pc:chgData name="Eva Herrero Serrano" userId="30ee73c8-4441-48c1-9b41-6efa0a64ae52" providerId="ADAL" clId="{73C8A755-2F19-1F40-B457-F6EEA28A134F}" dt="2025-07-02T13:32:19.567" v="5" actId="2696"/>
        <pc:sldMkLst>
          <pc:docMk/>
          <pc:sldMk cId="2941851669" sldId="406"/>
        </pc:sldMkLst>
      </pc:sldChg>
      <pc:sldChg chg="del">
        <pc:chgData name="Eva Herrero Serrano" userId="30ee73c8-4441-48c1-9b41-6efa0a64ae52" providerId="ADAL" clId="{73C8A755-2F19-1F40-B457-F6EEA28A134F}" dt="2025-07-02T13:32:17.684" v="1" actId="2696"/>
        <pc:sldMkLst>
          <pc:docMk/>
          <pc:sldMk cId="2152653418" sldId="407"/>
        </pc:sldMkLst>
      </pc:sldChg>
      <pc:sldChg chg="del">
        <pc:chgData name="Eva Herrero Serrano" userId="30ee73c8-4441-48c1-9b41-6efa0a64ae52" providerId="ADAL" clId="{73C8A755-2F19-1F40-B457-F6EEA28A134F}" dt="2025-07-02T13:32:18.182" v="2" actId="2696"/>
        <pc:sldMkLst>
          <pc:docMk/>
          <pc:sldMk cId="2384589629" sldId="408"/>
        </pc:sldMkLst>
      </pc:sldChg>
      <pc:sldChg chg="del">
        <pc:chgData name="Eva Herrero Serrano" userId="30ee73c8-4441-48c1-9b41-6efa0a64ae52" providerId="ADAL" clId="{73C8A755-2F19-1F40-B457-F6EEA28A134F}" dt="2025-07-02T13:32:19.114" v="4" actId="2696"/>
        <pc:sldMkLst>
          <pc:docMk/>
          <pc:sldMk cId="2625866172" sldId="409"/>
        </pc:sldMkLst>
      </pc:sldChg>
      <pc:sldChg chg="del">
        <pc:chgData name="Eva Herrero Serrano" userId="30ee73c8-4441-48c1-9b41-6efa0a64ae52" providerId="ADAL" clId="{73C8A755-2F19-1F40-B457-F6EEA28A134F}" dt="2025-07-02T13:32:18.594" v="3" actId="2696"/>
        <pc:sldMkLst>
          <pc:docMk/>
          <pc:sldMk cId="564929238" sldId="41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4303606" cy="3409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5497" y="0"/>
            <a:ext cx="4303606" cy="3409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0B9EA6-4523-204F-A38C-EB310BB9E6E6}" type="datetimeFigureOut">
              <a:rPr lang="en-US" smtClean="0"/>
              <a:t>7/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171950" y="849313"/>
            <a:ext cx="1587500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3140" y="3269853"/>
            <a:ext cx="7945120" cy="267533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6453596"/>
            <a:ext cx="4303606" cy="3409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5497" y="6453596"/>
            <a:ext cx="4303606" cy="34090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65B47-02A3-6545-81BD-CE096AC3AC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9780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noProof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2B65B47-02A3-6545-81BD-CE096AC3AC5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48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90749-87E1-654D-9347-98A262523D99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366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7A369A-2B05-6844-B0A9-E549CABD4D18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2881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C2C1AE-F068-A54F-BD59-F157D26CAF3B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6038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CA49AF-D4B1-B841-A3C6-0797BAE97B73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7357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8EC4B1-A988-4D40-8895-309A5922874F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504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A28266-E031-EE4A-AA5B-25E86C1B8835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672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181142-A245-CD4C-98EC-FE91F66445E5}" type="datetime1">
              <a:rPr lang="en-GB" smtClean="0"/>
              <a:t>02/0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482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9AF423-F805-2041-97CC-1A4994037567}" type="datetime1">
              <a:rPr lang="en-GB" smtClean="0"/>
              <a:t>02/0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0459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C91740-F340-7F42-A214-B550E62E5598}" type="datetime1">
              <a:rPr lang="en-GB" smtClean="0"/>
              <a:t>02/0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527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21EBA1-5261-ED4A-BA40-688502E8C4F1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586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38212F-31D4-CC4E-BBE9-0FE5E46009E3}" type="datetime1">
              <a:rPr lang="en-GB" smtClean="0"/>
              <a:t>02/0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9610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6F5EBD4-D993-2F4A-BC64-32375B140610}" type="datetime1">
              <a:rPr lang="en-GB" smtClean="0"/>
              <a:t>02/0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1DCAC0E-2F50-0143-987E-34B90C7828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35636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sv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svg"/><Relationship Id="rId5" Type="http://schemas.openxmlformats.org/officeDocument/2006/relationships/image" Target="../media/image3.png"/><Relationship Id="rId10" Type="http://schemas.openxmlformats.org/officeDocument/2006/relationships/image" Target="../media/image8.svg"/><Relationship Id="rId4" Type="http://schemas.openxmlformats.org/officeDocument/2006/relationships/image" Target="../media/image2.sv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Graphic 15">
            <a:extLst>
              <a:ext uri="{FF2B5EF4-FFF2-40B4-BE49-F238E27FC236}">
                <a16:creationId xmlns:a16="http://schemas.microsoft.com/office/drawing/2014/main" id="{74C86052-39F2-6E8F-D33F-90B5BB50E27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591872" y="1127863"/>
            <a:ext cx="2702616" cy="2034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788B13B-6248-6674-CA82-61B411309EB2}"/>
              </a:ext>
            </a:extLst>
          </p:cNvPr>
          <p:cNvSpPr txBox="1"/>
          <p:nvPr/>
        </p:nvSpPr>
        <p:spPr>
          <a:xfrm>
            <a:off x="438034" y="323576"/>
            <a:ext cx="59220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/>
              <a:t>Figure S1. Transcript abundance of MBW complex targets and circadian oscillator components in </a:t>
            </a:r>
            <a:r>
              <a:rPr lang="en-US" i="1" err="1"/>
              <a:t>tlwd</a:t>
            </a:r>
            <a:r>
              <a:rPr lang="en-US"/>
              <a:t> mutants </a:t>
            </a:r>
          </a:p>
        </p:txBody>
      </p:sp>
      <p:pic>
        <p:nvPicPr>
          <p:cNvPr id="4" name="Graphic 3">
            <a:extLst>
              <a:ext uri="{FF2B5EF4-FFF2-40B4-BE49-F238E27FC236}">
                <a16:creationId xmlns:a16="http://schemas.microsoft.com/office/drawing/2014/main" id="{E1BA60D5-E7BB-A938-4F2A-9705701B695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tretch>
            <a:fillRect/>
          </a:stretch>
        </p:blipFill>
        <p:spPr>
          <a:xfrm>
            <a:off x="3294488" y="1208234"/>
            <a:ext cx="3275814" cy="188457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386D25A-A290-E521-BF1B-6C4468449B36}"/>
              </a:ext>
            </a:extLst>
          </p:cNvPr>
          <p:cNvSpPr txBox="1"/>
          <p:nvPr/>
        </p:nvSpPr>
        <p:spPr>
          <a:xfrm rot="16200000">
            <a:off x="-275058" y="2020050"/>
            <a:ext cx="187109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000" b="1">
                <a:latin typeface="Arial" panose="020B0604020202020204" pitchFamily="34" charset="0"/>
                <a:cs typeface="Arial" panose="020B0604020202020204" pitchFamily="34" charset="0"/>
              </a:rPr>
              <a:t>Normalized counts</a:t>
            </a:r>
          </a:p>
        </p:txBody>
      </p:sp>
      <p:grpSp>
        <p:nvGrpSpPr>
          <p:cNvPr id="7" name="Group 6">
            <a:extLst>
              <a:ext uri="{FF2B5EF4-FFF2-40B4-BE49-F238E27FC236}">
                <a16:creationId xmlns:a16="http://schemas.microsoft.com/office/drawing/2014/main" id="{5B23CE74-4FCD-F384-208A-B8C5DD60589A}"/>
              </a:ext>
            </a:extLst>
          </p:cNvPr>
          <p:cNvGrpSpPr/>
          <p:nvPr/>
        </p:nvGrpSpPr>
        <p:grpSpPr>
          <a:xfrm>
            <a:off x="797161" y="3106113"/>
            <a:ext cx="2520000" cy="334452"/>
            <a:chOff x="354447" y="4418184"/>
            <a:chExt cx="2520000" cy="334452"/>
          </a:xfrm>
        </p:grpSpPr>
        <p:pic>
          <p:nvPicPr>
            <p:cNvPr id="8" name="Graphic 7">
              <a:extLst>
                <a:ext uri="{FF2B5EF4-FFF2-40B4-BE49-F238E27FC236}">
                  <a16:creationId xmlns:a16="http://schemas.microsoft.com/office/drawing/2014/main" id="{3101C629-DE0A-7249-6F56-F7E06226D35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96DAC541-7B7A-43D3-8B79-37D633B846F1}">
                  <asvg:svgBlip xmlns:asvg="http://schemas.microsoft.com/office/drawing/2016/SVG/main" r:embed="rId8"/>
                </a:ext>
              </a:extLst>
            </a:blip>
            <a:stretch>
              <a:fillRect/>
            </a:stretch>
          </p:blipFill>
          <p:spPr>
            <a:xfrm>
              <a:off x="354447" y="4418184"/>
              <a:ext cx="2520000" cy="171558"/>
            </a:xfrm>
            <a:prstGeom prst="rect">
              <a:avLst/>
            </a:prstGeom>
          </p:spPr>
        </p:pic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B5EFCFDD-D8F6-7F84-1C62-7BBE0C866B58}"/>
                </a:ext>
              </a:extLst>
            </p:cNvPr>
            <p:cNvGrpSpPr/>
            <p:nvPr/>
          </p:nvGrpSpPr>
          <p:grpSpPr>
            <a:xfrm>
              <a:off x="636378" y="4629041"/>
              <a:ext cx="1962988" cy="123595"/>
              <a:chOff x="4131816" y="3087577"/>
              <a:chExt cx="1962988" cy="123595"/>
            </a:xfrm>
          </p:grpSpPr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FC2697B7-4778-32D3-BD6E-FDFDFFE16CF2}"/>
                  </a:ext>
                </a:extLst>
              </p:cNvPr>
              <p:cNvSpPr txBox="1"/>
              <p:nvPr/>
            </p:nvSpPr>
            <p:spPr>
              <a:xfrm>
                <a:off x="5102971" y="3088061"/>
                <a:ext cx="991833" cy="12311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GB" sz="800" b="1">
                    <a:highlight>
                      <a:srgbClr val="F2F2F2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Night (6h after dusk)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030E3024-4E55-45BA-EB9A-061DDC938E53}"/>
                  </a:ext>
                </a:extLst>
              </p:cNvPr>
              <p:cNvSpPr txBox="1"/>
              <p:nvPr/>
            </p:nvSpPr>
            <p:spPr>
              <a:xfrm>
                <a:off x="4131816" y="3087577"/>
                <a:ext cx="951359" cy="123111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pPr algn="ctr"/>
                <a:r>
                  <a:rPr lang="en-GB" sz="800" b="1">
                    <a:highlight>
                      <a:srgbClr val="FFFD78"/>
                    </a:highlight>
                    <a:latin typeface="Arial" panose="020B0604020202020204" pitchFamily="34" charset="0"/>
                    <a:cs typeface="Arial" panose="020B0604020202020204" pitchFamily="34" charset="0"/>
                  </a:rPr>
                  <a:t>Day 6h after dawn)</a:t>
                </a:r>
              </a:p>
            </p:txBody>
          </p:sp>
        </p:grp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E5DABDE4-59FA-9B63-937E-436C57D33323}"/>
              </a:ext>
            </a:extLst>
          </p:cNvPr>
          <p:cNvSpPr txBox="1"/>
          <p:nvPr/>
        </p:nvSpPr>
        <p:spPr>
          <a:xfrm>
            <a:off x="480114" y="793588"/>
            <a:ext cx="415636" cy="338554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AB77FD0-2DF3-5606-E4E1-059CD8C9A267}"/>
              </a:ext>
            </a:extLst>
          </p:cNvPr>
          <p:cNvSpPr txBox="1"/>
          <p:nvPr/>
        </p:nvSpPr>
        <p:spPr>
          <a:xfrm>
            <a:off x="3381466" y="849730"/>
            <a:ext cx="415636" cy="338554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769D97E-823B-11A5-0A3D-9F400C6ECA6D}"/>
              </a:ext>
            </a:extLst>
          </p:cNvPr>
          <p:cNvSpPr txBox="1"/>
          <p:nvPr/>
        </p:nvSpPr>
        <p:spPr>
          <a:xfrm>
            <a:off x="480114" y="3539523"/>
            <a:ext cx="415636" cy="338554"/>
          </a:xfrm>
          <a:prstGeom prst="rect">
            <a:avLst/>
          </a:prstGeom>
          <a:noFill/>
        </p:spPr>
        <p:txBody>
          <a:bodyPr wrap="square" lIns="72000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7" name="Graphic 16">
            <a:extLst>
              <a:ext uri="{FF2B5EF4-FFF2-40B4-BE49-F238E27FC236}">
                <a16:creationId xmlns:a16="http://schemas.microsoft.com/office/drawing/2014/main" id="{689062DE-3F86-BECA-C83E-A400A61358F4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96DAC541-7B7A-43D3-8B79-37D633B846F1}">
                <asvg:svgBlip xmlns:asvg="http://schemas.microsoft.com/office/drawing/2016/SVG/main" r:embed="rId10"/>
              </a:ext>
            </a:extLst>
          </a:blip>
          <a:stretch>
            <a:fillRect/>
          </a:stretch>
        </p:blipFill>
        <p:spPr>
          <a:xfrm>
            <a:off x="501466" y="3738484"/>
            <a:ext cx="5760000" cy="3692180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7F0A7A1-CF9C-04A0-0946-03A5889EE0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4843463" y="9426495"/>
            <a:ext cx="1543050" cy="527403"/>
          </a:xfrm>
        </p:spPr>
        <p:txBody>
          <a:bodyPr/>
          <a:lstStyle/>
          <a:p>
            <a:fld id="{81DCAC0E-2F50-0143-987E-34B90C78281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607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4</Words>
  <Application>Microsoft Macintosh PowerPoint</Application>
  <PresentationFormat>A4 Paper (210x297 mm)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va Herrero Serrano</dc:creator>
  <cp:lastModifiedBy>Eva Herrero Serrano</cp:lastModifiedBy>
  <cp:revision>2</cp:revision>
  <cp:lastPrinted>2025-07-02T13:25:36Z</cp:lastPrinted>
  <dcterms:created xsi:type="dcterms:W3CDTF">2024-05-20T09:44:22Z</dcterms:created>
  <dcterms:modified xsi:type="dcterms:W3CDTF">2025-07-02T13:32:32Z</dcterms:modified>
</cp:coreProperties>
</file>